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8" d="100"/>
          <a:sy n="98" d="100"/>
        </p:scale>
        <p:origin x="110" y="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E03AA5E-C1A5-4CED-816E-CCCD1466E6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9956227-4344-4289-8362-4B508FA48E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911DC76-7BEF-452F-9672-AD8A052C8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AEFCEBB-15C4-4DB1-ACE3-7D5036292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9B22649-7784-48FF-966F-05B965D2F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9628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68ABF3-EE3B-4478-9D5D-5B95B3668E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880D990-6C9B-4EF0-8351-FCDF975E064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24C9D44-2D91-479F-8530-6CBCF7AAD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DD4B711-3C3C-4DE6-82F7-53746C205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EDC81F5-C687-4E0C-BC31-D80790840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1061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BBB4A8B-9D79-43E6-8350-F94B5B54CE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D492E98-7840-43F6-A3B6-6F6A13AE48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971D1DD-926F-4A31-B180-8CC205E21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82AC783-260E-411B-AD02-E20701A082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F4C5AD9-EEB6-4E60-ADC6-F74C14E09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8843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647AAF5-85DB-4D75-870D-8B46EF4DD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13BD187-4E39-4428-B5D3-2786B610EAC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EDEF5D7-9C91-49F8-981A-B6436014C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C2CE604-661C-48C4-B230-F9C3F158F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0462D1F-21BF-4FE6-8604-E673F626D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229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D1BC0A-2FB8-4AF1-99CF-10A5823AF3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F252BC0-3515-4E20-8507-0F8CBFBE83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E50F788-22B4-4C7B-AB0D-F4B22623A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9D56320-4671-4429-8927-B533D14C4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8A0E7B-96B5-456E-A1FE-8FDDA47D5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2425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D46C990-341E-4751-868D-42F4206557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357A2DD-B3D4-439D-BA15-EC8F934025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5F0F857-FFF6-4BBA-9EB3-AC4D84C1BC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3AA3732-5042-4B7F-8755-6B50B643A1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6B43919-BFCC-4510-9508-91FC3AF8C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8E4C7D5-4644-49D5-BD21-07BB03943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6449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09E23D-8167-4CF6-B283-6E7A3144B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6B907A2-729F-47C9-9977-052AE8A6CE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6C0AB3A-D487-4AC4-B255-0F342F7412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637E2058-3D5B-414C-9180-1E2EA02EF8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FB4AD63-16C4-4F13-A333-C1F24B5D93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FA21F53-A752-4EDB-BD3D-97A911598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FE8591DB-D36A-45D9-BE67-2A2CD8D89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1155B3F-A839-4C03-ADAF-A368C5CAB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0625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181363A-8DCF-439C-BE7D-FF170D43C7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6557529C-DE3A-4C72-93E8-43D78F607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A3139A2-B9D9-43E2-9DCB-68C05EDF6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5A9AC2B3-CC80-459C-838C-7CBA5633D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1719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DB46FCD-50F4-4482-B764-D3DA2319F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5A06A59-D1E6-4BDD-8C7D-EFF9A78F93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D538227D-EF58-4486-B11E-4728C8A49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6246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0B40F8-121F-4A79-BDAB-EC10C179BB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51BFC89-0DD7-410B-84CC-49B7CB97CD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E928F87-97D9-4C6F-8C52-07A6B21EF4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DFF14AE-44C1-4ADA-A300-51939CC80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BA299FB-ABE6-4803-B38A-707B6DAA89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8A08C7A-5463-4FBC-804C-657EA2C9C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4422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433DFFF-4EC5-47E3-95F8-5061939CD2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4E1A47E-B7B1-4073-8301-0252ACA938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BAA568B-126C-4EA4-8A40-CCB94E8BF4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3DA7EDA-2308-4CA0-B602-2C76AE9A10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A0C1703-98DB-43AA-B6AE-BBDC26CAA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BBC6475-827D-461C-8311-35D31F3B4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64005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84A92BE-E1AD-494D-9DC8-7001AFB74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C719128-D22C-4B2A-B1E3-F0450140EC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E3B2BD2-C033-4EAF-BF6C-520DDD1751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035E4-ACEB-4F70-9AA1-E1BCB2B89450}" type="datetimeFigureOut">
              <a:rPr lang="de-DE" smtClean="0"/>
              <a:t>05.01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9D8C7C0-4FD4-485F-93FC-DB1BFD000C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FBF4398-CEA8-4992-B056-0124A03D1A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E19CE6-8A60-48BF-B805-C3837F3F136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6618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8EABFB2C-1663-4BB3-9991-73F45D41F9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1866046"/>
              </p:ext>
            </p:extLst>
          </p:nvPr>
        </p:nvGraphicFramePr>
        <p:xfrm>
          <a:off x="426128" y="166446"/>
          <a:ext cx="6010181" cy="6525108"/>
        </p:xfrm>
        <a:graphic>
          <a:graphicData uri="http://schemas.openxmlformats.org/drawingml/2006/table">
            <a:tbl>
              <a:tblPr firstRow="1" bandRow="1" bandCol="1"/>
              <a:tblGrid>
                <a:gridCol w="825939">
                  <a:extLst>
                    <a:ext uri="{9D8B030D-6E8A-4147-A177-3AD203B41FA5}">
                      <a16:colId xmlns:a16="http://schemas.microsoft.com/office/drawing/2014/main" val="1097404828"/>
                    </a:ext>
                  </a:extLst>
                </a:gridCol>
                <a:gridCol w="825939">
                  <a:extLst>
                    <a:ext uri="{9D8B030D-6E8A-4147-A177-3AD203B41FA5}">
                      <a16:colId xmlns:a16="http://schemas.microsoft.com/office/drawing/2014/main" val="4247060082"/>
                    </a:ext>
                  </a:extLst>
                </a:gridCol>
                <a:gridCol w="825939">
                  <a:extLst>
                    <a:ext uri="{9D8B030D-6E8A-4147-A177-3AD203B41FA5}">
                      <a16:colId xmlns:a16="http://schemas.microsoft.com/office/drawing/2014/main" val="3020104538"/>
                    </a:ext>
                  </a:extLst>
                </a:gridCol>
                <a:gridCol w="825939">
                  <a:extLst>
                    <a:ext uri="{9D8B030D-6E8A-4147-A177-3AD203B41FA5}">
                      <a16:colId xmlns:a16="http://schemas.microsoft.com/office/drawing/2014/main" val="1482010120"/>
                    </a:ext>
                  </a:extLst>
                </a:gridCol>
                <a:gridCol w="825939">
                  <a:extLst>
                    <a:ext uri="{9D8B030D-6E8A-4147-A177-3AD203B41FA5}">
                      <a16:colId xmlns:a16="http://schemas.microsoft.com/office/drawing/2014/main" val="823055223"/>
                    </a:ext>
                  </a:extLst>
                </a:gridCol>
                <a:gridCol w="825939">
                  <a:extLst>
                    <a:ext uri="{9D8B030D-6E8A-4147-A177-3AD203B41FA5}">
                      <a16:colId xmlns:a16="http://schemas.microsoft.com/office/drawing/2014/main" val="1802248678"/>
                    </a:ext>
                  </a:extLst>
                </a:gridCol>
                <a:gridCol w="626829">
                  <a:extLst>
                    <a:ext uri="{9D8B030D-6E8A-4147-A177-3AD203B41FA5}">
                      <a16:colId xmlns:a16="http://schemas.microsoft.com/office/drawing/2014/main" val="49824529"/>
                    </a:ext>
                  </a:extLst>
                </a:gridCol>
                <a:gridCol w="427718">
                  <a:extLst>
                    <a:ext uri="{9D8B030D-6E8A-4147-A177-3AD203B41FA5}">
                      <a16:colId xmlns:a16="http://schemas.microsoft.com/office/drawing/2014/main" val="4270036182"/>
                    </a:ext>
                  </a:extLst>
                </a:gridCol>
              </a:tblGrid>
              <a:tr h="250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ume &lt; 29.9 (n=7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0 &lt;= Volume &lt; 59.9 (n=32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.0 &lt;= Volume &lt; 89.9 (n=22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.0 &lt;= Volume &lt; 119.9 (n=2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olume &gt;= 120 (n=1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(n=64)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6855840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1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7034391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 (93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 (95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2792699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6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4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6931813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5843783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861667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917746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0810116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2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538700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71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 (90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 (95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 (90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6102058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28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6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6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479201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2166695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456512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7018419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644792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3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7726739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 (87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(90.9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7 (89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5963337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9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7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796208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9496337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661634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46029671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58486687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4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506073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83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 (87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81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 (85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19017566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6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9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13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1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7551203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9092319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580409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55736163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994218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raction # 5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6771040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83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 (84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 (84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 (85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804765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fiducial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6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12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 (11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851628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5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97777451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79244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fiducials not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784767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916951"/>
                  </a:ext>
                </a:extLst>
              </a:tr>
              <a:tr h="2509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undetected fiducials</a:t>
                      </a:r>
                      <a:endParaRPr lang="de-DE" sz="5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86779785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71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 (84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81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 (82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29462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687954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13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4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04177780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6612091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4.3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6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(4.7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9527506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4.5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3.1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7542122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8032715"/>
                  </a:ext>
                </a:extLst>
              </a:tr>
              <a:tr h="250964"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undetected fiducials per grou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6276076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detected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71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 (84.4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 (81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(10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 (82.8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0513534"/>
                  </a:ext>
                </a:extLst>
              </a:tr>
              <a:tr h="250964">
                <a:tc>
                  <a:txBody>
                    <a:bodyPr/>
                    <a:lstStyle/>
                    <a:p>
                      <a:pPr algn="l" fontAlgn="ctr"/>
                      <a:r>
                        <a:rPr lang="de-DE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t least 1 undetected fiducia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(28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(15.6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 (18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0.0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 (17.2%)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0948613"/>
                  </a:ext>
                </a:extLst>
              </a:tr>
              <a:tr h="125483">
                <a:tc>
                  <a:txBody>
                    <a:bodyPr/>
                    <a:lstStyle/>
                    <a:p>
                      <a:pPr algn="l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ssing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endParaRPr lang="de-DE" sz="5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  <a:endParaRPr lang="de-DE" sz="5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9464048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C0D1E0C1-FF18-40FD-84DB-3627432EA01E}"/>
              </a:ext>
            </a:extLst>
          </p:cNvPr>
          <p:cNvSpPr txBox="1"/>
          <p:nvPr/>
        </p:nvSpPr>
        <p:spPr>
          <a:xfrm>
            <a:off x="6738152" y="166446"/>
            <a:ext cx="5202314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/>
              <a:t>Table </a:t>
            </a:r>
            <a:r>
              <a:rPr lang="de-DE" sz="1100" b="1" smtClean="0"/>
              <a:t>5. </a:t>
            </a:r>
            <a:r>
              <a:rPr lang="de-DE" sz="1100" b="1" dirty="0" err="1"/>
              <a:t>Fiducial</a:t>
            </a:r>
            <a:r>
              <a:rPr lang="de-DE" sz="1100" b="1" dirty="0"/>
              <a:t> </a:t>
            </a:r>
            <a:r>
              <a:rPr lang="de-DE" sz="1100" b="1" dirty="0" err="1"/>
              <a:t>detection</a:t>
            </a:r>
            <a:r>
              <a:rPr lang="de-DE" sz="1100" b="1" dirty="0"/>
              <a:t> rate </a:t>
            </a:r>
            <a:r>
              <a:rPr lang="de-DE" sz="1100" b="1" dirty="0" err="1"/>
              <a:t>by</a:t>
            </a:r>
            <a:r>
              <a:rPr lang="de-DE" sz="1100" b="1" dirty="0"/>
              <a:t> </a:t>
            </a:r>
            <a:r>
              <a:rPr lang="de-DE" sz="1100" b="1" dirty="0" err="1"/>
              <a:t>prostate</a:t>
            </a:r>
            <a:r>
              <a:rPr lang="de-DE" sz="1100" b="1" dirty="0"/>
              <a:t> </a:t>
            </a:r>
            <a:r>
              <a:rPr lang="de-DE" sz="1100" b="1" dirty="0" err="1"/>
              <a:t>volume</a:t>
            </a:r>
            <a:r>
              <a:rPr lang="de-DE" sz="1100" b="1" dirty="0"/>
              <a:t> </a:t>
            </a:r>
            <a:r>
              <a:rPr lang="de-DE" sz="1100" b="1" dirty="0" err="1"/>
              <a:t>group</a:t>
            </a:r>
            <a:r>
              <a:rPr lang="de-DE" sz="1100" b="1" dirty="0"/>
              <a:t>. </a:t>
            </a:r>
            <a:r>
              <a:rPr lang="de-DE" sz="1100" dirty="0"/>
              <a:t>The </a:t>
            </a:r>
            <a:r>
              <a:rPr lang="de-DE" sz="1100" dirty="0" err="1"/>
              <a:t>prostate</a:t>
            </a:r>
            <a:r>
              <a:rPr lang="de-DE" sz="1100" dirty="0"/>
              <a:t> </a:t>
            </a:r>
            <a:r>
              <a:rPr lang="de-DE" sz="1100" dirty="0" err="1"/>
              <a:t>volume</a:t>
            </a:r>
            <a:r>
              <a:rPr lang="de-DE" sz="1100" dirty="0"/>
              <a:t> </a:t>
            </a:r>
            <a:r>
              <a:rPr lang="de-DE" sz="1100" dirty="0" err="1"/>
              <a:t>groups</a:t>
            </a:r>
            <a:r>
              <a:rPr lang="de-DE" sz="1100" dirty="0"/>
              <a:t> </a:t>
            </a:r>
            <a:r>
              <a:rPr lang="de-DE" sz="1100" dirty="0" err="1"/>
              <a:t>were</a:t>
            </a:r>
            <a:r>
              <a:rPr lang="de-DE" sz="1100" dirty="0"/>
              <a:t> </a:t>
            </a:r>
            <a:r>
              <a:rPr lang="de-DE" sz="1100" dirty="0" err="1"/>
              <a:t>devised</a:t>
            </a:r>
            <a:r>
              <a:rPr lang="de-DE" sz="1100" dirty="0"/>
              <a:t> </a:t>
            </a:r>
            <a:r>
              <a:rPr lang="de-DE" sz="1100" dirty="0" err="1"/>
              <a:t>by</a:t>
            </a:r>
            <a:r>
              <a:rPr lang="de-DE" sz="1100" dirty="0"/>
              <a:t> </a:t>
            </a:r>
            <a:r>
              <a:rPr lang="de-DE" sz="1100" dirty="0" err="1"/>
              <a:t>starting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a normal </a:t>
            </a:r>
            <a:r>
              <a:rPr lang="de-DE" sz="1100" dirty="0" err="1"/>
              <a:t>volume</a:t>
            </a:r>
            <a:r>
              <a:rPr lang="de-DE" sz="1100" dirty="0"/>
              <a:t> of </a:t>
            </a:r>
            <a:r>
              <a:rPr lang="de-DE" sz="1100" dirty="0" err="1"/>
              <a:t>up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30 ml and </a:t>
            </a:r>
            <a:r>
              <a:rPr lang="de-DE" sz="1100" dirty="0" err="1"/>
              <a:t>then</a:t>
            </a:r>
            <a:r>
              <a:rPr lang="de-DE" sz="1100" dirty="0"/>
              <a:t> </a:t>
            </a:r>
            <a:r>
              <a:rPr lang="de-DE" sz="1100" dirty="0" err="1"/>
              <a:t>proceding</a:t>
            </a:r>
            <a:r>
              <a:rPr lang="de-DE" sz="1100" dirty="0"/>
              <a:t> in 30 ml </a:t>
            </a:r>
            <a:r>
              <a:rPr lang="de-DE" sz="1100" dirty="0" err="1"/>
              <a:t>steps</a:t>
            </a:r>
            <a:r>
              <a:rPr lang="de-DE" sz="1100" dirty="0"/>
              <a:t>. N = the </a:t>
            </a:r>
            <a:r>
              <a:rPr lang="de-DE" sz="1100" dirty="0" err="1"/>
              <a:t>whole</a:t>
            </a:r>
            <a:r>
              <a:rPr lang="de-DE" sz="1100" dirty="0"/>
              <a:t> </a:t>
            </a:r>
            <a:r>
              <a:rPr lang="de-DE" sz="1100" dirty="0" err="1"/>
              <a:t>cohort</a:t>
            </a:r>
            <a:r>
              <a:rPr lang="de-DE" sz="1100" dirty="0"/>
              <a:t> (64). There was </a:t>
            </a:r>
            <a:r>
              <a:rPr lang="de-DE" sz="1100" dirty="0" err="1"/>
              <a:t>no</a:t>
            </a:r>
            <a:r>
              <a:rPr lang="de-DE" sz="1100" dirty="0"/>
              <a:t> </a:t>
            </a:r>
            <a:r>
              <a:rPr lang="de-DE" sz="1100" dirty="0" err="1"/>
              <a:t>significant</a:t>
            </a:r>
            <a:r>
              <a:rPr lang="de-DE" sz="1100" dirty="0"/>
              <a:t> </a:t>
            </a:r>
            <a:r>
              <a:rPr lang="de-DE" sz="1100" dirty="0" err="1"/>
              <a:t>difference</a:t>
            </a:r>
            <a:r>
              <a:rPr lang="de-DE" sz="1100" dirty="0"/>
              <a:t> </a:t>
            </a:r>
            <a:r>
              <a:rPr lang="de-DE" sz="1100" dirty="0" err="1"/>
              <a:t>between</a:t>
            </a:r>
            <a:r>
              <a:rPr lang="de-DE" sz="1100" dirty="0"/>
              <a:t> the </a:t>
            </a:r>
            <a:r>
              <a:rPr lang="de-DE" sz="1100" dirty="0" err="1"/>
              <a:t>groups</a:t>
            </a:r>
            <a:r>
              <a:rPr lang="de-DE" sz="1100" dirty="0"/>
              <a:t> over the course of </a:t>
            </a:r>
            <a:r>
              <a:rPr lang="de-DE" sz="1100" dirty="0" err="1"/>
              <a:t>the</a:t>
            </a:r>
            <a:r>
              <a:rPr lang="de-DE" sz="1100" dirty="0"/>
              <a:t> 5-</a:t>
            </a:r>
            <a:r>
              <a:rPr lang="de-DE" sz="1100" dirty="0" err="1"/>
              <a:t>fraction</a:t>
            </a:r>
            <a:r>
              <a:rPr lang="de-DE" sz="1100" dirty="0"/>
              <a:t> treatment </a:t>
            </a:r>
            <a:r>
              <a:rPr lang="de-DE" sz="1100" dirty="0" err="1"/>
              <a:t>although</a:t>
            </a:r>
            <a:r>
              <a:rPr lang="de-DE" sz="1100" dirty="0"/>
              <a:t> the </a:t>
            </a:r>
            <a:r>
              <a:rPr lang="de-DE" sz="1100" dirty="0" err="1"/>
              <a:t>overall</a:t>
            </a:r>
            <a:r>
              <a:rPr lang="de-DE" sz="1100" dirty="0"/>
              <a:t> rate of </a:t>
            </a:r>
            <a:r>
              <a:rPr lang="de-DE" sz="1100" dirty="0" err="1"/>
              <a:t>undetected</a:t>
            </a:r>
            <a:r>
              <a:rPr lang="de-DE" sz="1100" dirty="0"/>
              <a:t> fiducials </a:t>
            </a:r>
            <a:r>
              <a:rPr lang="de-DE" sz="1100" dirty="0" err="1"/>
              <a:t>increased</a:t>
            </a:r>
            <a:r>
              <a:rPr lang="de-DE" sz="1100" dirty="0"/>
              <a:t> </a:t>
            </a:r>
            <a:r>
              <a:rPr lang="de-DE" sz="1100" dirty="0" err="1"/>
              <a:t>significantly</a:t>
            </a:r>
            <a:r>
              <a:rPr lang="de-DE" sz="1100" dirty="0"/>
              <a:t> from fraction </a:t>
            </a:r>
            <a:r>
              <a:rPr lang="de-DE" sz="1100" dirty="0" err="1"/>
              <a:t>one</a:t>
            </a:r>
            <a:r>
              <a:rPr lang="de-DE" sz="1100" dirty="0"/>
              <a:t> </a:t>
            </a:r>
            <a:r>
              <a:rPr lang="de-DE" sz="1100" dirty="0" err="1"/>
              <a:t>to</a:t>
            </a:r>
            <a:r>
              <a:rPr lang="de-DE" sz="1100" dirty="0"/>
              <a:t> </a:t>
            </a:r>
            <a:r>
              <a:rPr lang="de-DE" sz="1100" dirty="0" err="1"/>
              <a:t>five</a:t>
            </a:r>
            <a:r>
              <a:rPr lang="de-DE" sz="11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220225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hteck 1">
            <a:extLst>
              <a:ext uri="{FF2B5EF4-FFF2-40B4-BE49-F238E27FC236}">
                <a16:creationId xmlns:a16="http://schemas.microsoft.com/office/drawing/2014/main" id="{E57A01C6-0D4D-46E6-A826-9E5F8F1D65F9}"/>
              </a:ext>
            </a:extLst>
          </p:cNvPr>
          <p:cNvSpPr/>
          <p:nvPr/>
        </p:nvSpPr>
        <p:spPr>
          <a:xfrm>
            <a:off x="3048000" y="857238"/>
            <a:ext cx="6096000" cy="51435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Implant Geometry and Detection Rates of Prostate Fiducial Markers after Trans-Rectal-Ultrasound-Guided Perineal Implantation for Image-Guided 6D-Tracking Robotic Stereotactic Body Radiotherap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Strahlentherap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und </a:t>
            </a:r>
            <a:r>
              <a:rPr lang="en-US" sz="1100" dirty="0" err="1">
                <a:latin typeface="Calibri" panose="020F0502020204030204" pitchFamily="34" charset="0"/>
                <a:ea typeface="Times New Roman" panose="02020603050405020304" pitchFamily="18" charset="0"/>
              </a:rPr>
              <a:t>Onkologie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Katharina Heil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</a:t>
            </a: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aniel Zips, Goda Kalinauskaite</a:t>
            </a: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, Dirk Boehmer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 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Corresponding Author: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rne Gruen, MD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Department for Radiation Oncology,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harité </a:t>
            </a:r>
            <a:r>
              <a:rPr lang="en-US" sz="1100" i="1" dirty="0">
                <a:latin typeface="Calibri" panose="020F0502020204030204" pitchFamily="34" charset="0"/>
                <a:ea typeface="Calibri" panose="020F0502020204030204" pitchFamily="34" charset="0"/>
              </a:rPr>
              <a:t>– </a:t>
            </a: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Universitaetsmedizin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Calibri" panose="020F0502020204030204" pitchFamily="34" charset="0"/>
              </a:rPr>
              <a:t>Corporate member of Freie Universitaet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Calibri" panose="020F0502020204030204" pitchFamily="34" charset="0"/>
              </a:rPr>
              <a:t>Humboldt-Universitaet zu Berlin and Berlin Institute of Health</a:t>
            </a: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Campus Virchow-Klinikum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Augustenburger Platz 1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de-DE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13353 Berlin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Germany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Tel: 0049-30-450-6272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Fax: 0049-30-450-7527152 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Email: </a:t>
            </a:r>
            <a:r>
              <a:rPr lang="en-GB" sz="1100" b="1" dirty="0">
                <a:latin typeface="Calibri" panose="020F0502020204030204" pitchFamily="34" charset="0"/>
                <a:ea typeface="Times New Roman" panose="02020603050405020304" pitchFamily="18" charset="0"/>
              </a:rPr>
              <a:t>arne.gruen@charite.de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dirty="0">
                <a:latin typeface="Calibri" panose="020F0502020204030204" pitchFamily="34" charset="0"/>
                <a:ea typeface="Times New Roman" panose="02020603050405020304" pitchFamily="18" charset="0"/>
              </a:rPr>
              <a:t>ORCID: 0000-0002-3868-2719</a:t>
            </a:r>
            <a:endParaRPr lang="de-DE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0500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2</Words>
  <Application>Microsoft Office PowerPoint</Application>
  <PresentationFormat>Breitbild</PresentationFormat>
  <Paragraphs>404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rün, Arne</dc:creator>
  <cp:lastModifiedBy>A</cp:lastModifiedBy>
  <cp:revision>9</cp:revision>
  <dcterms:created xsi:type="dcterms:W3CDTF">2024-08-03T07:51:17Z</dcterms:created>
  <dcterms:modified xsi:type="dcterms:W3CDTF">2025-01-05T13:58:25Z</dcterms:modified>
</cp:coreProperties>
</file>